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0000000-0000-0000-0000-000000000000}" name="作成者" initials="A" userId="Author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82" autoAdjust="0"/>
    <p:restoredTop sz="94709"/>
  </p:normalViewPr>
  <p:slideViewPr>
    <p:cSldViewPr snapToGrid="0">
      <p:cViewPr varScale="1">
        <p:scale>
          <a:sx n="103" d="100"/>
          <a:sy n="103" d="100"/>
        </p:scale>
        <p:origin x="216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18B128-A0F4-F89F-D8E2-0FE2628A3C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9DE171A-0169-33FF-86F5-E2B876C2F08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EE493A8-07A7-A678-67DC-3A58700E5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FB424-20E2-4849-83FD-07EB1C9F0EF5}" type="datetimeFigureOut">
              <a:rPr kumimoji="1" lang="ja-JP" altLang="en-US" smtClean="0"/>
              <a:t>2025/4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D3353DE-03FD-6E15-2784-FE7814234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EE4D41-67F1-F79A-F00F-D9A231552E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AA05C-B3D4-4C8E-9CFF-984BE1018F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1396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D231C0-27D5-1D36-797F-B182181219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397C5EF-7588-63E0-3AC5-FA548D3F3E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4627122-47B2-4087-0319-4DACEA66E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FB424-20E2-4849-83FD-07EB1C9F0EF5}" type="datetimeFigureOut">
              <a:rPr kumimoji="1" lang="ja-JP" altLang="en-US" smtClean="0"/>
              <a:t>2025/4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8DE0EC-A7C0-E285-69F1-F21065EDC9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8AD1CFF-400D-7941-1FE3-59ACB442E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AA05C-B3D4-4C8E-9CFF-984BE1018F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7622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BD1316D-6509-84E8-39FE-2F56E0D525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46D545C-4F73-E3D7-8A6D-F502BC6F10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53B474D-1DAD-EE59-75BF-63C04CD50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FB424-20E2-4849-83FD-07EB1C9F0EF5}" type="datetimeFigureOut">
              <a:rPr kumimoji="1" lang="ja-JP" altLang="en-US" smtClean="0"/>
              <a:t>2025/4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94117E-AE39-E9D6-F5B2-4BF1AE0420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D1D6761-5484-5B6A-60FB-ED8C2EBFF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AA05C-B3D4-4C8E-9CFF-984BE1018F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4415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3852B4-0D0F-8EBC-3A3C-916FFC8F79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D2C008E-E863-3B0D-CF23-9D9F52B057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273BF68-FF72-DBA7-1FA7-3536129047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FB424-20E2-4849-83FD-07EB1C9F0EF5}" type="datetimeFigureOut">
              <a:rPr kumimoji="1" lang="ja-JP" altLang="en-US" smtClean="0"/>
              <a:t>2025/4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0E14F6-EB3B-E3DE-0D8A-E9CEE0451A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9FF1722-B849-364C-0285-E4362DFD7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AA05C-B3D4-4C8E-9CFF-984BE1018F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112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BB026E-4585-E6DF-DE0B-9C98BC48DA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F22E2C7-77F0-0695-FCCA-F8588FF283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5434374-EE09-2332-ECB8-45DEBB0BE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FB424-20E2-4849-83FD-07EB1C9F0EF5}" type="datetimeFigureOut">
              <a:rPr kumimoji="1" lang="ja-JP" altLang="en-US" smtClean="0"/>
              <a:t>2025/4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F0B1008-3E07-86B1-3042-B9AB2A5B85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A028E97-483D-BECC-9B72-25621F394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AA05C-B3D4-4C8E-9CFF-984BE1018F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4668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D6475A-B2A6-4B39-8DA8-B0075D24FF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04A0134-E12F-13A4-028D-C2103E7D86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1B9779D-0620-6D0D-D802-FFE792316F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91CF832-8809-C0C1-52B8-A69183C9D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FB424-20E2-4849-83FD-07EB1C9F0EF5}" type="datetimeFigureOut">
              <a:rPr kumimoji="1" lang="ja-JP" altLang="en-US" smtClean="0"/>
              <a:t>2025/4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DF1DFFA-8AF5-DAD4-BEEA-D26C05BA20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B9CFED9-6A78-1A7A-B402-25A3F0BF1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AA05C-B3D4-4C8E-9CFF-984BE1018F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7766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5DBA45-248E-A5E3-3F88-1470A04770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17FD9B0-476F-A4DE-7227-817CB8824F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AB505AD-DC5F-D5E8-BFA1-F3D8B17CA9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7424D65-A92E-C4E0-0EB5-F1D4843C4C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6002596-8DB5-A819-5EC3-CA8B57FB17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3E60EF7-EAE0-49CD-E1CB-D7F5E48E4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FB424-20E2-4849-83FD-07EB1C9F0EF5}" type="datetimeFigureOut">
              <a:rPr kumimoji="1" lang="ja-JP" altLang="en-US" smtClean="0"/>
              <a:t>2025/4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EC931CD-31CB-2E36-DBDF-A7D8A9EC66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3619889-1380-AAE3-1489-D0FBFDAAE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AA05C-B3D4-4C8E-9CFF-984BE1018F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873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6DD58C-BB4E-8F6E-096E-F5F54EBADD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01CBA4B-9AF4-2F6C-D9FA-947C9AEBA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FB424-20E2-4849-83FD-07EB1C9F0EF5}" type="datetimeFigureOut">
              <a:rPr kumimoji="1" lang="ja-JP" altLang="en-US" smtClean="0"/>
              <a:t>2025/4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E2B85E3-353C-E57C-FA62-FC859DEC08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AA6B101-B148-2D27-917E-E9210008DB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AA05C-B3D4-4C8E-9CFF-984BE1018F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3136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931F0CB-3BC1-F797-8386-3A4453184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FB424-20E2-4849-83FD-07EB1C9F0EF5}" type="datetimeFigureOut">
              <a:rPr kumimoji="1" lang="ja-JP" altLang="en-US" smtClean="0"/>
              <a:t>2025/4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576257C-806F-8C88-0855-FCC823053E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C2C07C4-07D7-7BB6-431C-FA11B84766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AA05C-B3D4-4C8E-9CFF-984BE1018F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3278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B0E15D-8B44-215A-863E-0B2589B5B9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560F984-F6D1-8BC0-DEE4-FF2BC997DD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57B102A-52F8-E5FF-5F75-1E68B750D3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5518F36-9CC0-B6BA-B413-052C1F574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FB424-20E2-4849-83FD-07EB1C9F0EF5}" type="datetimeFigureOut">
              <a:rPr kumimoji="1" lang="ja-JP" altLang="en-US" smtClean="0"/>
              <a:t>2025/4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2A7C976-78CD-78A5-ABF8-E06E42F802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32AEDA1-3FC8-938E-51FB-DF9217268B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AA05C-B3D4-4C8E-9CFF-984BE1018F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6778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E2985D0-EE85-9275-4F70-820A87BC4B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D970615-F4C2-6EAA-E570-5E60DADD8A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1088158-C6BD-03C7-1B86-38E959DD76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8727F66-9DAE-31CF-15B8-47D9ED2313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FB424-20E2-4849-83FD-07EB1C9F0EF5}" type="datetimeFigureOut">
              <a:rPr kumimoji="1" lang="ja-JP" altLang="en-US" smtClean="0"/>
              <a:t>2025/4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0ECD469-BC97-0917-BDD7-CDCA4E1E91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4FC3BEE-A552-087A-A986-990F1A60A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7AA05C-B3D4-4C8E-9CFF-984BE1018F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0331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DF64523-B9F1-A24C-9DCC-EBD82741DD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955467E-682A-D605-F74D-17841AF8D7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DE9C088-1874-C3AD-4049-260E4737DF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EFB424-20E2-4849-83FD-07EB1C9F0EF5}" type="datetimeFigureOut">
              <a:rPr kumimoji="1" lang="ja-JP" altLang="en-US" smtClean="0"/>
              <a:t>2025/4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1D68BC9-3821-5EDE-1606-34CA429499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833D372-7EF4-B9C4-B66F-183DFF3D7D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7AA05C-B3D4-4C8E-9CFF-984BE1018F0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6808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A7E1B728-3B64-4D05-8FDA-5626F789D631}"/>
              </a:ext>
            </a:extLst>
          </p:cNvPr>
          <p:cNvGrpSpPr/>
          <p:nvPr/>
        </p:nvGrpSpPr>
        <p:grpSpPr>
          <a:xfrm>
            <a:off x="172941" y="-77625"/>
            <a:ext cx="4406932" cy="6935625"/>
            <a:chOff x="706498" y="-97724"/>
            <a:chExt cx="4406932" cy="6935625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A33834AA-AC70-2D91-188F-1B48F7333EB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08640" y="0"/>
              <a:ext cx="4004790" cy="6837901"/>
            </a:xfrm>
            <a:prstGeom prst="rect">
              <a:avLst/>
            </a:prstGeom>
          </p:spPr>
        </p:pic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37D8CE9-EC52-2596-D16B-78A741190CEB}"/>
                </a:ext>
              </a:extLst>
            </p:cNvPr>
            <p:cNvSpPr txBox="1"/>
            <p:nvPr/>
          </p:nvSpPr>
          <p:spPr>
            <a:xfrm>
              <a:off x="706498" y="-97724"/>
              <a:ext cx="48122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3200" b="1" dirty="0">
                  <a:latin typeface="Arial "/>
                </a:rPr>
                <a:t>A</a:t>
              </a:r>
              <a:endParaRPr kumimoji="1" lang="ja-JP" altLang="en-US" sz="3200" b="1" dirty="0">
                <a:latin typeface="Arial "/>
              </a:endParaRPr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C755F605-9CCF-07F7-5A10-8DDF8E158670}"/>
              </a:ext>
            </a:extLst>
          </p:cNvPr>
          <p:cNvGrpSpPr/>
          <p:nvPr/>
        </p:nvGrpSpPr>
        <p:grpSpPr>
          <a:xfrm>
            <a:off x="5114761" y="-97724"/>
            <a:ext cx="1992971" cy="6955724"/>
            <a:chOff x="5757210" y="-97724"/>
            <a:chExt cx="1992971" cy="6955724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FFDCD693-013F-CDED-B580-F7C4DAF6428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80272" y="0"/>
              <a:ext cx="1669909" cy="6858000"/>
            </a:xfrm>
            <a:prstGeom prst="rect">
              <a:avLst/>
            </a:prstGeom>
          </p:spPr>
        </p:pic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BB19F50C-900E-7D7C-C0D1-E6A909BAA4CD}"/>
                </a:ext>
              </a:extLst>
            </p:cNvPr>
            <p:cNvSpPr txBox="1"/>
            <p:nvPr/>
          </p:nvSpPr>
          <p:spPr>
            <a:xfrm>
              <a:off x="5757210" y="-97724"/>
              <a:ext cx="48122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3200" b="1" dirty="0">
                  <a:latin typeface="Arial "/>
                </a:rPr>
                <a:t>B</a:t>
              </a:r>
              <a:endParaRPr kumimoji="1" lang="ja-JP" altLang="en-US" sz="3200" b="1" dirty="0">
                <a:latin typeface="Arial "/>
              </a:endParaRPr>
            </a:p>
          </p:txBody>
        </p:sp>
      </p:grp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6A74863-20F1-0AB7-8A75-51F1820824D2}"/>
              </a:ext>
            </a:extLst>
          </p:cNvPr>
          <p:cNvSpPr txBox="1"/>
          <p:nvPr/>
        </p:nvSpPr>
        <p:spPr>
          <a:xfrm>
            <a:off x="7107732" y="4476919"/>
            <a:ext cx="4872441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dirty="0">
                <a:latin typeface="Arial "/>
              </a:rPr>
              <a:t>Figure S</a:t>
            </a:r>
            <a:r>
              <a:rPr lang="en-US" altLang="ja-JP" dirty="0">
                <a:latin typeface="Arial "/>
              </a:rPr>
              <a:t>3</a:t>
            </a:r>
          </a:p>
          <a:p>
            <a:r>
              <a:rPr lang="en-US" altLang="ja-JP" dirty="0">
                <a:latin typeface="Arial "/>
              </a:rPr>
              <a:t>The automated programs on </a:t>
            </a:r>
            <a:r>
              <a:rPr lang="en-US" altLang="ja-JP" dirty="0" err="1">
                <a:latin typeface="Arial "/>
              </a:rPr>
              <a:t>Maholo</a:t>
            </a:r>
            <a:r>
              <a:rPr lang="en-US" altLang="ja-JP" dirty="0">
                <a:latin typeface="Arial "/>
              </a:rPr>
              <a:t>.</a:t>
            </a:r>
          </a:p>
          <a:p>
            <a:r>
              <a:rPr lang="en-US" altLang="ja-JP" dirty="0">
                <a:latin typeface="Arial "/>
              </a:rPr>
              <a:t>A: </a:t>
            </a:r>
            <a:r>
              <a:rPr lang="en-US" altLang="ja-JP" dirty="0">
                <a:latin typeface="Arial "/>
                <a:cs typeface="Arial" panose="020B0604020202020204" pitchFamily="34" charset="0"/>
              </a:rPr>
              <a:t>p</a:t>
            </a:r>
            <a:r>
              <a:rPr kumimoji="1" lang="en-US" altLang="ja-JP" dirty="0">
                <a:latin typeface="Arial "/>
                <a:cs typeface="Arial" panose="020B0604020202020204" pitchFamily="34" charset="0"/>
              </a:rPr>
              <a:t>rogram for DNA extraction and preparation of the TaqMan qPCR assay; 76 p</a:t>
            </a:r>
            <a:r>
              <a:rPr lang="en-US" altLang="ja-JP" dirty="0">
                <a:latin typeface="Arial "/>
              </a:rPr>
              <a:t>rocesses</a:t>
            </a:r>
            <a:r>
              <a:rPr lang="en-US" altLang="ja-JP" dirty="0">
                <a:latin typeface="Arial "/>
                <a:cs typeface="Arial" panose="020B0604020202020204" pitchFamily="34" charset="0"/>
              </a:rPr>
              <a:t>, B:</a:t>
            </a:r>
            <a:r>
              <a:rPr lang="ja-JP" altLang="en-US" dirty="0">
                <a:latin typeface="Arial 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 "/>
                <a:cs typeface="Arial" panose="020B0604020202020204" pitchFamily="34" charset="0"/>
              </a:rPr>
              <a:t>program for creation of DNA library; 187 processes.</a:t>
            </a:r>
          </a:p>
          <a:p>
            <a:r>
              <a:rPr lang="en-US" altLang="ja-JP" dirty="0">
                <a:latin typeface="Arial "/>
                <a:cs typeface="Arial" panose="020B0604020202020204" pitchFamily="34" charset="0"/>
              </a:rPr>
              <a:t> </a:t>
            </a:r>
            <a:endParaRPr lang="ja-JP" altLang="en-US" dirty="0">
              <a:latin typeface="Arial "/>
            </a:endParaRPr>
          </a:p>
        </p:txBody>
      </p:sp>
    </p:spTree>
    <p:extLst>
      <p:ext uri="{BB962C8B-B14F-4D97-AF65-F5344CB8AC3E}">
        <p14:creationId xmlns:p14="http://schemas.microsoft.com/office/powerpoint/2010/main" val="17716782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</Words>
  <Application>Microsoft Office PowerPoint</Application>
  <PresentationFormat>ワイド画面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 </vt:lpstr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SCI</cp:lastModifiedBy>
  <cp:revision>2</cp:revision>
  <dcterms:created xsi:type="dcterms:W3CDTF">2025-04-30T00:20:40Z</dcterms:created>
  <dcterms:modified xsi:type="dcterms:W3CDTF">2025-04-30T00:20:53Z</dcterms:modified>
</cp:coreProperties>
</file>